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61" autoAdjust="0"/>
    <p:restoredTop sz="94660"/>
  </p:normalViewPr>
  <p:slideViewPr>
    <p:cSldViewPr snapToGrid="0">
      <p:cViewPr>
        <p:scale>
          <a:sx n="45" d="100"/>
          <a:sy n="45" d="100"/>
        </p:scale>
        <p:origin x="-2640" y="13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515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147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1334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379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38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7827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8691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474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57415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26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7605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C59F4-C791-43FF-9756-3FC7D79AA024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38DAA-5E06-4933-9AD3-7F3763FDC6B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379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7" Type="http://schemas.openxmlformats.org/officeDocument/2006/relationships/image" Target="../media/image22.tif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tiff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57" y="1965556"/>
            <a:ext cx="2534837" cy="194991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1865" y="2180960"/>
            <a:ext cx="2201227" cy="143828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82905" y="1774216"/>
            <a:ext cx="15840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 weight (all studie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82471" y="1774216"/>
            <a:ext cx="24048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rth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ght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high quality studies only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7916" y="1438310"/>
            <a:ext cx="1847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85310" y="396192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crosomia (all studie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/>
          <p:cNvPicPr/>
          <p:nvPr/>
        </p:nvPicPr>
        <p:blipFill>
          <a:blip r:embed="rId4"/>
          <a:stretch>
            <a:fillRect/>
          </a:stretch>
        </p:blipFill>
        <p:spPr>
          <a:xfrm>
            <a:off x="473717" y="4477637"/>
            <a:ext cx="2286447" cy="1565248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680407" y="3953873"/>
            <a:ext cx="24000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crosomia (high quality studies only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/>
          <p:cNvPicPr/>
          <p:nvPr/>
        </p:nvPicPr>
        <p:blipFill>
          <a:blip r:embed="rId5"/>
          <a:stretch>
            <a:fillRect/>
          </a:stretch>
        </p:blipFill>
        <p:spPr>
          <a:xfrm>
            <a:off x="3680407" y="4477637"/>
            <a:ext cx="2331896" cy="1565248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48030" y="6190136"/>
            <a:ext cx="11689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A (all studie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/>
          <p:cNvPicPr/>
          <p:nvPr/>
        </p:nvPicPr>
        <p:blipFill>
          <a:blip r:embed="rId6"/>
          <a:stretch>
            <a:fillRect/>
          </a:stretch>
        </p:blipFill>
        <p:spPr>
          <a:xfrm>
            <a:off x="473717" y="6653317"/>
            <a:ext cx="2305377" cy="1606591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680407" y="6190136"/>
            <a:ext cx="19896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A (high quality studies only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80407" y="6588598"/>
            <a:ext cx="2400016" cy="167131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151337" y="2515505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22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1.23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188680" y="2515505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21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0.83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32408" y="4719039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31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1.00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452534" y="4719038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02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2.25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32407" y="7256557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50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0.66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452534" y="7256557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32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0.99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82905" y="8492355"/>
            <a:ext cx="11608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A (all studie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Picture 17"/>
          <p:cNvPicPr/>
          <p:nvPr/>
        </p:nvPicPr>
        <p:blipFill>
          <a:blip r:embed="rId8"/>
          <a:stretch>
            <a:fillRect/>
          </a:stretch>
        </p:blipFill>
        <p:spPr>
          <a:xfrm>
            <a:off x="448030" y="8787746"/>
            <a:ext cx="2396189" cy="1685096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582471" y="8492355"/>
            <a:ext cx="19816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A (high quality studies only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80407" y="8887078"/>
            <a:ext cx="2400016" cy="1585764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2148767" y="9086080"/>
            <a:ext cx="5597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=0.39</a:t>
            </a:r>
          </a:p>
          <a:p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=0.85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8648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tretch>
            <a:fillRect/>
          </a:stretch>
        </p:blipFill>
        <p:spPr>
          <a:xfrm>
            <a:off x="370188" y="1318885"/>
            <a:ext cx="2444750" cy="165354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14325" y="1028700"/>
            <a:ext cx="11144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height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/>
          <p:nvPr/>
        </p:nvPicPr>
        <p:blipFill>
          <a:blip r:embed="rId3"/>
          <a:stretch>
            <a:fillRect/>
          </a:stretch>
        </p:blipFill>
        <p:spPr>
          <a:xfrm>
            <a:off x="3520516" y="1394781"/>
            <a:ext cx="2444750" cy="15576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471862" y="1057275"/>
            <a:ext cx="21595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abdominal circumferenc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2979" y="3350354"/>
            <a:ext cx="18325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head circumferenc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20516" y="3350354"/>
            <a:ext cx="18549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chest circumferenc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/>
          <p:nvPr/>
        </p:nvPicPr>
        <p:blipFill>
          <a:blip r:embed="rId4"/>
          <a:stretch>
            <a:fillRect/>
          </a:stretch>
        </p:blipFill>
        <p:spPr>
          <a:xfrm>
            <a:off x="337819" y="3938026"/>
            <a:ext cx="2477119" cy="1572413"/>
          </a:xfrm>
          <a:prstGeom prst="rect">
            <a:avLst/>
          </a:prstGeom>
        </p:spPr>
      </p:pic>
      <p:pic>
        <p:nvPicPr>
          <p:cNvPr id="9" name="Picture 8"/>
          <p:cNvPicPr/>
          <p:nvPr/>
        </p:nvPicPr>
        <p:blipFill>
          <a:blip r:embed="rId5"/>
          <a:stretch>
            <a:fillRect/>
          </a:stretch>
        </p:blipFill>
        <p:spPr>
          <a:xfrm>
            <a:off x="3520516" y="3914739"/>
            <a:ext cx="2424430" cy="1696073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91994" y="5805805"/>
            <a:ext cx="18373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nderal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dex (PI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/>
          <p:nvPr/>
        </p:nvPicPr>
        <p:blipFill>
          <a:blip r:embed="rId6"/>
          <a:stretch>
            <a:fillRect/>
          </a:stretch>
        </p:blipFill>
        <p:spPr>
          <a:xfrm>
            <a:off x="291994" y="6265836"/>
            <a:ext cx="2444750" cy="169607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flipH="1">
            <a:off x="3581555" y="5805805"/>
            <a:ext cx="31242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ant weight (18m-2yrs) 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/>
          <p:nvPr/>
        </p:nvPicPr>
        <p:blipFill>
          <a:blip r:embed="rId7"/>
          <a:stretch>
            <a:fillRect/>
          </a:stretch>
        </p:blipFill>
        <p:spPr>
          <a:xfrm>
            <a:off x="3520516" y="6247194"/>
            <a:ext cx="2493404" cy="17432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02110" y="8257275"/>
            <a:ext cx="15728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fant height (18m-2yr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581555" y="8257275"/>
            <a:ext cx="1685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weight (5-9yr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4082" y="8649690"/>
            <a:ext cx="3157618" cy="2371236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48" y="8649690"/>
            <a:ext cx="2660190" cy="23712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833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156" y="2219325"/>
            <a:ext cx="16530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height (5-9yr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/>
          <a:stretch>
            <a:fillRect/>
          </a:stretch>
        </p:blipFill>
        <p:spPr>
          <a:xfrm>
            <a:off x="250156" y="2633662"/>
            <a:ext cx="2686050" cy="17240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12456" y="2219325"/>
            <a:ext cx="15680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ldhood BMI (5-9yr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/>
          <p:nvPr/>
        </p:nvPicPr>
        <p:blipFill>
          <a:blip r:embed="rId3"/>
          <a:stretch>
            <a:fillRect/>
          </a:stretch>
        </p:blipFill>
        <p:spPr>
          <a:xfrm>
            <a:off x="3412456" y="2633662"/>
            <a:ext cx="2612390" cy="17240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6831" y="5040943"/>
            <a:ext cx="237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 </a:t>
            </a:r>
            <a:endParaRPr lang="en-GB" dirty="0"/>
          </a:p>
        </p:txBody>
      </p:sp>
      <p:pic>
        <p:nvPicPr>
          <p:cNvPr id="19" name="Picture 18"/>
          <p:cNvPicPr/>
          <p:nvPr/>
        </p:nvPicPr>
        <p:blipFill>
          <a:blip r:embed="rId4"/>
          <a:stretch>
            <a:fillRect/>
          </a:stretch>
        </p:blipFill>
        <p:spPr>
          <a:xfrm>
            <a:off x="316831" y="5177468"/>
            <a:ext cx="2734945" cy="1809750"/>
          </a:xfrm>
          <a:prstGeom prst="rect">
            <a:avLst/>
          </a:prstGeom>
        </p:spPr>
      </p:pic>
      <p:pic>
        <p:nvPicPr>
          <p:cNvPr id="20" name="Picture 19"/>
          <p:cNvPicPr/>
          <p:nvPr/>
        </p:nvPicPr>
        <p:blipFill>
          <a:blip r:embed="rId5"/>
          <a:stretch>
            <a:fillRect/>
          </a:stretch>
        </p:blipFill>
        <p:spPr>
          <a:xfrm>
            <a:off x="3412456" y="5136193"/>
            <a:ext cx="2876550" cy="185102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316831" y="4826957"/>
            <a:ext cx="2406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head circumference (7-9yrs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412456" y="4826957"/>
            <a:ext cx="2428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est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mference (7-9yr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4865" y="7456488"/>
            <a:ext cx="24368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ist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mference (7-9yr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488657" y="7456488"/>
            <a:ext cx="19880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ildhood </a:t>
            </a:r>
            <a:r>
              <a:rPr lang="en-GB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ist:height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7-9yrs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64" y="7715209"/>
            <a:ext cx="3035233" cy="299239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3341" y="7715211"/>
            <a:ext cx="3275665" cy="2992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640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462" y="1790701"/>
            <a:ext cx="2829071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71462" y="1280723"/>
            <a:ext cx="13837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hildhood fat mas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7087" y="1790701"/>
            <a:ext cx="2829071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271837" y="1280722"/>
            <a:ext cx="18742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hildhood abdominal mas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462" y="4767648"/>
            <a:ext cx="2829071" cy="19716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5734" y="4281100"/>
            <a:ext cx="2222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hildhood abdominal fat volume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37728" y="4281099"/>
            <a:ext cx="3098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bdominal subcutaneous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fat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volume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7728" y="4864269"/>
            <a:ext cx="2795589" cy="1866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419632" y="7611159"/>
            <a:ext cx="24541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visceral fat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volume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821" y="8287436"/>
            <a:ext cx="2829071" cy="19716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741724" y="7602318"/>
            <a:ext cx="13933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Childhood thigh fat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3907" y="8287436"/>
            <a:ext cx="2924321" cy="19716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625403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6001" y="1586297"/>
            <a:ext cx="1316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arm fat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001" y="2064007"/>
            <a:ext cx="2840024" cy="21269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641719" y="1586297"/>
            <a:ext cx="2364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bicep skinfold thicknes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1719" y="2064006"/>
            <a:ext cx="2840024" cy="21269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24731" y="4671625"/>
            <a:ext cx="23823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err="1" smtClean="0">
                <a:latin typeface="Times New Roman" pitchFamily="18" charset="0"/>
                <a:cs typeface="Times New Roman" pitchFamily="18" charset="0"/>
              </a:rPr>
              <a:t>tricep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skinfol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thicknes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732" y="5226307"/>
            <a:ext cx="2966931" cy="21079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682988" y="4671624"/>
            <a:ext cx="27574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Childhoo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subscapular 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skinfold </a:t>
            </a:r>
            <a:r>
              <a:rPr lang="en-GB" sz="1200" dirty="0" smtClean="0">
                <a:latin typeface="Times New Roman" pitchFamily="18" charset="0"/>
                <a:cs typeface="Times New Roman" pitchFamily="18" charset="0"/>
              </a:rPr>
              <a:t>thicknes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2988" y="5226307"/>
            <a:ext cx="2877361" cy="2107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24731" y="9897979"/>
            <a:ext cx="14013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Fig: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nel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7700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5</TotalTime>
  <Words>172</Words>
  <Application>Microsoft Office PowerPoint</Application>
  <PresentationFormat>Custom</PresentationFormat>
  <Paragraphs>4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Windows User</cp:lastModifiedBy>
  <cp:revision>34</cp:revision>
  <cp:lastPrinted>2019-05-01T07:39:24Z</cp:lastPrinted>
  <dcterms:created xsi:type="dcterms:W3CDTF">2019-01-31T10:32:10Z</dcterms:created>
  <dcterms:modified xsi:type="dcterms:W3CDTF">2019-06-08T18:50:13Z</dcterms:modified>
</cp:coreProperties>
</file>